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64" r:id="rId2"/>
    <p:sldId id="256" r:id="rId3"/>
    <p:sldId id="259" r:id="rId4"/>
    <p:sldId id="265" r:id="rId5"/>
    <p:sldId id="258" r:id="rId6"/>
    <p:sldId id="266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4694"/>
  </p:normalViewPr>
  <p:slideViewPr>
    <p:cSldViewPr snapToGrid="0">
      <p:cViewPr>
        <p:scale>
          <a:sx n="76" d="100"/>
          <a:sy n="76" d="100"/>
        </p:scale>
        <p:origin x="3328" y="4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890451-7224-7F42-AB27-FEEC5849FFFA}" type="datetimeFigureOut">
              <a:rPr lang="en-US" smtClean="0"/>
              <a:t>5/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A23756-BE02-DA44-B624-698482673B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3237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81C8722-5E45-94A8-2D07-46F06A435F4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E90260C9-2AAF-225C-2022-41482C28EF7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492B03BF-5248-C95D-C614-83E03ED6D0B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F8B28A-D488-4004-D387-DA4D969590B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556419-E077-E64D-8123-5187F9212CB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15616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8CEAF-AC3A-2C4D-BC3E-A976DA92C573}" type="datetimeFigureOut">
              <a:rPr lang="en-US" smtClean="0"/>
              <a:t>5/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B9C3B-628F-8A47-8DA0-AFFFA72B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364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8CEAF-AC3A-2C4D-BC3E-A976DA92C573}" type="datetimeFigureOut">
              <a:rPr lang="en-US" smtClean="0"/>
              <a:t>5/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B9C3B-628F-8A47-8DA0-AFFFA72B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254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8CEAF-AC3A-2C4D-BC3E-A976DA92C573}" type="datetimeFigureOut">
              <a:rPr lang="en-US" smtClean="0"/>
              <a:t>5/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B9C3B-628F-8A47-8DA0-AFFFA72B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375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8CEAF-AC3A-2C4D-BC3E-A976DA92C573}" type="datetimeFigureOut">
              <a:rPr lang="en-US" smtClean="0"/>
              <a:t>5/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B9C3B-628F-8A47-8DA0-AFFFA72B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630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8CEAF-AC3A-2C4D-BC3E-A976DA92C573}" type="datetimeFigureOut">
              <a:rPr lang="en-US" smtClean="0"/>
              <a:t>5/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B9C3B-628F-8A47-8DA0-AFFFA72B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845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8CEAF-AC3A-2C4D-BC3E-A976DA92C573}" type="datetimeFigureOut">
              <a:rPr lang="en-US" smtClean="0"/>
              <a:t>5/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B9C3B-628F-8A47-8DA0-AFFFA72B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1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8CEAF-AC3A-2C4D-BC3E-A976DA92C573}" type="datetimeFigureOut">
              <a:rPr lang="en-US" smtClean="0"/>
              <a:t>5/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B9C3B-628F-8A47-8DA0-AFFFA72B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491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8CEAF-AC3A-2C4D-BC3E-A976DA92C573}" type="datetimeFigureOut">
              <a:rPr lang="en-US" smtClean="0"/>
              <a:t>5/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B9C3B-628F-8A47-8DA0-AFFFA72B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335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8CEAF-AC3A-2C4D-BC3E-A976DA92C573}" type="datetimeFigureOut">
              <a:rPr lang="en-US" smtClean="0"/>
              <a:t>5/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B9C3B-628F-8A47-8DA0-AFFFA72B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642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8CEAF-AC3A-2C4D-BC3E-A976DA92C573}" type="datetimeFigureOut">
              <a:rPr lang="en-US" smtClean="0"/>
              <a:t>5/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B9C3B-628F-8A47-8DA0-AFFFA72B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024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8CEAF-AC3A-2C4D-BC3E-A976DA92C573}" type="datetimeFigureOut">
              <a:rPr lang="en-US" smtClean="0"/>
              <a:t>5/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CB9C3B-628F-8A47-8DA0-AFFFA72B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6488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D8CEAF-AC3A-2C4D-BC3E-A976DA92C573}" type="datetimeFigureOut">
              <a:rPr lang="en-US" smtClean="0"/>
              <a:t>5/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3CB9C3B-628F-8A47-8DA0-AFFFA72B6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582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sv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7EE292A-5C67-56AC-1033-DC29F2730F1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Graphic 29">
            <a:extLst>
              <a:ext uri="{FF2B5EF4-FFF2-40B4-BE49-F238E27FC236}">
                <a16:creationId xmlns:a16="http://schemas.microsoft.com/office/drawing/2014/main" id="{AB3CD180-08C9-4F79-DD4B-0736889857D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054639" y="717866"/>
            <a:ext cx="2748722" cy="6689904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D0C2AB3D-4439-4D07-BEC0-23581D068566}"/>
              </a:ext>
            </a:extLst>
          </p:cNvPr>
          <p:cNvSpPr txBox="1"/>
          <p:nvPr/>
        </p:nvSpPr>
        <p:spPr>
          <a:xfrm>
            <a:off x="2189763" y="363923"/>
            <a:ext cx="4683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SD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560FEA4-46AF-77F6-9694-44323B87B641}"/>
              </a:ext>
            </a:extLst>
          </p:cNvPr>
          <p:cNvSpPr txBox="1"/>
          <p:nvPr/>
        </p:nvSpPr>
        <p:spPr>
          <a:xfrm>
            <a:off x="2850811" y="363923"/>
            <a:ext cx="4459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LD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2015420-8397-5234-9DA7-0A1D963140AF}"/>
              </a:ext>
            </a:extLst>
          </p:cNvPr>
          <p:cNvSpPr txBox="1"/>
          <p:nvPr/>
        </p:nvSpPr>
        <p:spPr>
          <a:xfrm>
            <a:off x="3537017" y="142838"/>
            <a:ext cx="4683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LD</a:t>
            </a:r>
          </a:p>
          <a:p>
            <a:r>
              <a:rPr lang="en-US" sz="1600" dirty="0">
                <a:latin typeface="Helvetica" pitchFamily="2" charset="0"/>
              </a:rPr>
              <a:t>SD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E356080-5FEC-E363-CC3A-0F95BEB156F5}"/>
              </a:ext>
            </a:extLst>
          </p:cNvPr>
          <p:cNvSpPr txBox="1"/>
          <p:nvPr/>
        </p:nvSpPr>
        <p:spPr>
          <a:xfrm>
            <a:off x="4252525" y="142837"/>
            <a:ext cx="4683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SD</a:t>
            </a:r>
          </a:p>
          <a:p>
            <a:r>
              <a:rPr lang="en-US" sz="1600" dirty="0">
                <a:latin typeface="Helvetica" pitchFamily="2" charset="0"/>
              </a:rPr>
              <a:t>LD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03EA64E-4159-7D8C-DB9A-C4712E68D5D9}"/>
              </a:ext>
            </a:extLst>
          </p:cNvPr>
          <p:cNvSpPr txBox="1"/>
          <p:nvPr/>
        </p:nvSpPr>
        <p:spPr>
          <a:xfrm>
            <a:off x="1370843" y="1070619"/>
            <a:ext cx="6639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Ws-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0909F91-8656-F2B1-0950-FE687951E259}"/>
              </a:ext>
            </a:extLst>
          </p:cNvPr>
          <p:cNvSpPr txBox="1"/>
          <p:nvPr/>
        </p:nvSpPr>
        <p:spPr>
          <a:xfrm>
            <a:off x="1496910" y="2168262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latin typeface="Helvetica" pitchFamily="2" charset="0"/>
              </a:rPr>
              <a:t>Tnz</a:t>
            </a:r>
            <a:endParaRPr lang="en-US" sz="1600" dirty="0">
              <a:latin typeface="Helvetica" pitchFamily="2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FD119CF-A5BB-9A1B-0908-695750DD1E97}"/>
              </a:ext>
            </a:extLst>
          </p:cNvPr>
          <p:cNvSpPr txBox="1"/>
          <p:nvPr/>
        </p:nvSpPr>
        <p:spPr>
          <a:xfrm>
            <a:off x="1311574" y="3278839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Bay-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4FA9A1C-0357-A1A5-3015-51D82F45D24C}"/>
              </a:ext>
            </a:extLst>
          </p:cNvPr>
          <p:cNvSpPr txBox="1"/>
          <p:nvPr/>
        </p:nvSpPr>
        <p:spPr>
          <a:xfrm>
            <a:off x="1494565" y="4389416"/>
            <a:ext cx="5485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Sh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37CB382-6DD7-20D8-86B9-B0DC96FCF0DF}"/>
              </a:ext>
            </a:extLst>
          </p:cNvPr>
          <p:cNvSpPr txBox="1"/>
          <p:nvPr/>
        </p:nvSpPr>
        <p:spPr>
          <a:xfrm>
            <a:off x="1529030" y="5521465"/>
            <a:ext cx="4796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latin typeface="Helvetica" pitchFamily="2" charset="0"/>
              </a:rPr>
              <a:t>Cvi</a:t>
            </a:r>
            <a:endParaRPr lang="en-US" sz="1600" dirty="0">
              <a:latin typeface="Helvetica" pitchFamily="2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FF86B1F-AA30-C3FC-4F91-74422D7ADAF2}"/>
              </a:ext>
            </a:extLst>
          </p:cNvPr>
          <p:cNvSpPr txBox="1"/>
          <p:nvPr/>
        </p:nvSpPr>
        <p:spPr>
          <a:xfrm>
            <a:off x="1494565" y="6588970"/>
            <a:ext cx="5485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Sap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52F08B4-9FF2-0495-8A62-B0BD91B0C062}"/>
              </a:ext>
            </a:extLst>
          </p:cNvPr>
          <p:cNvSpPr txBox="1"/>
          <p:nvPr/>
        </p:nvSpPr>
        <p:spPr>
          <a:xfrm>
            <a:off x="-45720" y="7489371"/>
            <a:ext cx="6903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8101999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5E35825-51BD-ED40-986E-92B8734B635D}"/>
              </a:ext>
            </a:extLst>
          </p:cNvPr>
          <p:cNvSpPr txBox="1"/>
          <p:nvPr/>
        </p:nvSpPr>
        <p:spPr>
          <a:xfrm>
            <a:off x="-45720" y="7489371"/>
            <a:ext cx="6903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2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B1FA9A6-9458-C964-5A92-00B04F2EEF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9000" y="176629"/>
            <a:ext cx="4800000" cy="72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98797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6F3B458-C212-17A7-8434-FCF035E2AB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8999" y="176629"/>
            <a:ext cx="4800001" cy="7200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947F601-2C0B-60C0-42C6-2DE65F093857}"/>
              </a:ext>
            </a:extLst>
          </p:cNvPr>
          <p:cNvSpPr txBox="1"/>
          <p:nvPr/>
        </p:nvSpPr>
        <p:spPr>
          <a:xfrm>
            <a:off x="-45720" y="7489371"/>
            <a:ext cx="6903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7966055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F39800B-B673-682A-6F14-30CC7B78F148}"/>
              </a:ext>
            </a:extLst>
          </p:cNvPr>
          <p:cNvSpPr txBox="1"/>
          <p:nvPr/>
        </p:nvSpPr>
        <p:spPr>
          <a:xfrm>
            <a:off x="2099485" y="615645"/>
            <a:ext cx="4683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S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DCD54E-729A-729B-A6C9-3773FC402AD1}"/>
              </a:ext>
            </a:extLst>
          </p:cNvPr>
          <p:cNvSpPr txBox="1"/>
          <p:nvPr/>
        </p:nvSpPr>
        <p:spPr>
          <a:xfrm>
            <a:off x="2998807" y="613923"/>
            <a:ext cx="4459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L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7A9772B-B60D-8EE0-19A0-BF5F3C28AF3A}"/>
              </a:ext>
            </a:extLst>
          </p:cNvPr>
          <p:cNvSpPr txBox="1"/>
          <p:nvPr/>
        </p:nvSpPr>
        <p:spPr>
          <a:xfrm>
            <a:off x="3917897" y="367702"/>
            <a:ext cx="4683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LD</a:t>
            </a:r>
          </a:p>
          <a:p>
            <a:r>
              <a:rPr lang="en-US" sz="1600" dirty="0">
                <a:latin typeface="Helvetica" pitchFamily="2" charset="0"/>
              </a:rPr>
              <a:t>S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AF7BE48-9489-676D-2C33-62D850424729}"/>
              </a:ext>
            </a:extLst>
          </p:cNvPr>
          <p:cNvSpPr txBox="1"/>
          <p:nvPr/>
        </p:nvSpPr>
        <p:spPr>
          <a:xfrm>
            <a:off x="4844374" y="367702"/>
            <a:ext cx="4683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SD</a:t>
            </a:r>
          </a:p>
          <a:p>
            <a:r>
              <a:rPr lang="en-US" sz="1600" dirty="0">
                <a:latin typeface="Helvetica" pitchFamily="2" charset="0"/>
              </a:rPr>
              <a:t>LD</a:t>
            </a:r>
          </a:p>
        </p:txBody>
      </p:sp>
      <p:pic>
        <p:nvPicPr>
          <p:cNvPr id="32" name="Graphic 31">
            <a:extLst>
              <a:ext uri="{FF2B5EF4-FFF2-40B4-BE49-F238E27FC236}">
                <a16:creationId xmlns:a16="http://schemas.microsoft.com/office/drawing/2014/main" id="{7E2503B6-8829-475E-103A-AE1237EF83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841877" y="952477"/>
            <a:ext cx="3655065" cy="6015286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1BE232E0-B2D3-F955-4FA5-CD92B7578525}"/>
              </a:ext>
            </a:extLst>
          </p:cNvPr>
          <p:cNvSpPr txBox="1"/>
          <p:nvPr/>
        </p:nvSpPr>
        <p:spPr>
          <a:xfrm>
            <a:off x="964430" y="1491841"/>
            <a:ext cx="6639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Ws-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1DC4AB8-2333-C1C5-C9EE-88A38443C78A}"/>
              </a:ext>
            </a:extLst>
          </p:cNvPr>
          <p:cNvSpPr txBox="1"/>
          <p:nvPr/>
        </p:nvSpPr>
        <p:spPr>
          <a:xfrm>
            <a:off x="947598" y="2979381"/>
            <a:ext cx="6976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>
                <a:latin typeface="Helvetica" pitchFamily="2" charset="0"/>
              </a:rPr>
              <a:t>elf3-4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043320D-B7AA-1A89-DE6F-421680833D79}"/>
              </a:ext>
            </a:extLst>
          </p:cNvPr>
          <p:cNvSpPr txBox="1"/>
          <p:nvPr/>
        </p:nvSpPr>
        <p:spPr>
          <a:xfrm>
            <a:off x="822566" y="4467287"/>
            <a:ext cx="9476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>
                <a:latin typeface="Helvetica" pitchFamily="2" charset="0"/>
              </a:rPr>
              <a:t>phyB-1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7681EA0-E32F-6506-B954-128410DF67FD}"/>
              </a:ext>
            </a:extLst>
          </p:cNvPr>
          <p:cNvSpPr txBox="1"/>
          <p:nvPr/>
        </p:nvSpPr>
        <p:spPr>
          <a:xfrm>
            <a:off x="894182" y="5955193"/>
            <a:ext cx="94769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>
                <a:latin typeface="Helvetica" pitchFamily="2" charset="0"/>
              </a:rPr>
              <a:t>elf3-4</a:t>
            </a:r>
          </a:p>
          <a:p>
            <a:r>
              <a:rPr lang="en-US" sz="1600" i="1" dirty="0">
                <a:latin typeface="Helvetica" pitchFamily="2" charset="0"/>
              </a:rPr>
              <a:t>phyB-1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355CDD7-0B2C-3214-FB4F-30FA1126A3BF}"/>
              </a:ext>
            </a:extLst>
          </p:cNvPr>
          <p:cNvSpPr txBox="1"/>
          <p:nvPr/>
        </p:nvSpPr>
        <p:spPr>
          <a:xfrm>
            <a:off x="-45720" y="7489371"/>
            <a:ext cx="6903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41587317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8E01F68D-F93B-DADA-33BC-0416FC9AC58B}"/>
              </a:ext>
            </a:extLst>
          </p:cNvPr>
          <p:cNvGrpSpPr/>
          <p:nvPr/>
        </p:nvGrpSpPr>
        <p:grpSpPr>
          <a:xfrm>
            <a:off x="1237805" y="0"/>
            <a:ext cx="4382390" cy="8749796"/>
            <a:chOff x="872606" y="449584"/>
            <a:chExt cx="4382390" cy="8749796"/>
          </a:xfrm>
        </p:grpSpPr>
        <p:pic>
          <p:nvPicPr>
            <p:cNvPr id="3" name="Picture 2" descr="A group of graphs with numbers&#10;&#10;Description automatically generated with medium confidence">
              <a:extLst>
                <a:ext uri="{FF2B5EF4-FFF2-40B4-BE49-F238E27FC236}">
                  <a16:creationId xmlns:a16="http://schemas.microsoft.com/office/drawing/2014/main" id="{188877C4-E7A6-697E-C44C-069A946E36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34282"/>
            <a:stretch/>
          </p:blipFill>
          <p:spPr>
            <a:xfrm>
              <a:off x="872606" y="449584"/>
              <a:ext cx="4382390" cy="43200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9D06D30-E5DD-0375-4DF6-377B7C240C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34282"/>
            <a:stretch/>
          </p:blipFill>
          <p:spPr>
            <a:xfrm>
              <a:off x="876257" y="4882980"/>
              <a:ext cx="4378739" cy="4316400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1F5F0EEC-2041-033B-9C97-6A2C1BFE7DBE}"/>
              </a:ext>
            </a:extLst>
          </p:cNvPr>
          <p:cNvSpPr txBox="1"/>
          <p:nvPr/>
        </p:nvSpPr>
        <p:spPr>
          <a:xfrm>
            <a:off x="0" y="8863192"/>
            <a:ext cx="6903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681E5B0-5E68-4065-B967-501849F08D5F}"/>
              </a:ext>
            </a:extLst>
          </p:cNvPr>
          <p:cNvSpPr txBox="1"/>
          <p:nvPr/>
        </p:nvSpPr>
        <p:spPr>
          <a:xfrm>
            <a:off x="674557" y="134911"/>
            <a:ext cx="3433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D7DBDC3-7D52-FF41-1188-00A439BBBB12}"/>
              </a:ext>
            </a:extLst>
          </p:cNvPr>
          <p:cNvSpPr txBox="1"/>
          <p:nvPr/>
        </p:nvSpPr>
        <p:spPr>
          <a:xfrm>
            <a:off x="674557" y="4387344"/>
            <a:ext cx="3433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942065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1F5F0EEC-2041-033B-9C97-6A2C1BFE7DBE}"/>
              </a:ext>
            </a:extLst>
          </p:cNvPr>
          <p:cNvSpPr txBox="1"/>
          <p:nvPr/>
        </p:nvSpPr>
        <p:spPr>
          <a:xfrm>
            <a:off x="0" y="8863192"/>
            <a:ext cx="6903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6</a:t>
            </a:r>
          </a:p>
        </p:txBody>
      </p:sp>
      <p:pic>
        <p:nvPicPr>
          <p:cNvPr id="2" name="Graphic 1">
            <a:extLst>
              <a:ext uri="{FF2B5EF4-FFF2-40B4-BE49-F238E27FC236}">
                <a16:creationId xmlns:a16="http://schemas.microsoft.com/office/drawing/2014/main" id="{17B318F5-6856-3C9C-E55A-D101C49204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013627" y="952477"/>
            <a:ext cx="3330015" cy="587808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329BC04-AF83-3A0D-F3BB-DC21CD4A2163}"/>
              </a:ext>
            </a:extLst>
          </p:cNvPr>
          <p:cNvSpPr txBox="1"/>
          <p:nvPr/>
        </p:nvSpPr>
        <p:spPr>
          <a:xfrm>
            <a:off x="2140641" y="627309"/>
            <a:ext cx="4683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S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0D57FD2-691A-9825-1B19-5DA347E41070}"/>
              </a:ext>
            </a:extLst>
          </p:cNvPr>
          <p:cNvSpPr txBox="1"/>
          <p:nvPr/>
        </p:nvSpPr>
        <p:spPr>
          <a:xfrm>
            <a:off x="3005904" y="613922"/>
            <a:ext cx="4459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L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463BFB9-19A0-3C14-D382-9F1D5C2BBE15}"/>
              </a:ext>
            </a:extLst>
          </p:cNvPr>
          <p:cNvSpPr txBox="1"/>
          <p:nvPr/>
        </p:nvSpPr>
        <p:spPr>
          <a:xfrm>
            <a:off x="3858018" y="381088"/>
            <a:ext cx="4683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LD</a:t>
            </a:r>
          </a:p>
          <a:p>
            <a:r>
              <a:rPr lang="en-US" sz="1600" dirty="0">
                <a:latin typeface="Helvetica" pitchFamily="2" charset="0"/>
              </a:rPr>
              <a:t>S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43CFE38-9876-540A-A4D7-326C7E1E8ADA}"/>
              </a:ext>
            </a:extLst>
          </p:cNvPr>
          <p:cNvSpPr txBox="1"/>
          <p:nvPr/>
        </p:nvSpPr>
        <p:spPr>
          <a:xfrm>
            <a:off x="4739672" y="367701"/>
            <a:ext cx="4683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SD</a:t>
            </a:r>
          </a:p>
          <a:p>
            <a:r>
              <a:rPr lang="en-US" sz="1600" dirty="0">
                <a:latin typeface="Helvetica" pitchFamily="2" charset="0"/>
              </a:rPr>
              <a:t>L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CD42E08-FCA5-7A0B-2392-5D0A4A90D8B0}"/>
              </a:ext>
            </a:extLst>
          </p:cNvPr>
          <p:cNvSpPr txBox="1"/>
          <p:nvPr/>
        </p:nvSpPr>
        <p:spPr>
          <a:xfrm>
            <a:off x="515034" y="1613084"/>
            <a:ext cx="146193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Helvetica" pitchFamily="2" charset="0"/>
              </a:rPr>
              <a:t>Kale </a:t>
            </a:r>
          </a:p>
          <a:p>
            <a:pPr algn="ctr"/>
            <a:r>
              <a:rPr lang="en-US" sz="1600" dirty="0">
                <a:latin typeface="Helvetica" pitchFamily="2" charset="0"/>
              </a:rPr>
              <a:t>(Tozer Seeds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F7F18FC-73C8-1C62-2D12-33B1412E87FC}"/>
              </a:ext>
            </a:extLst>
          </p:cNvPr>
          <p:cNvSpPr txBox="1"/>
          <p:nvPr/>
        </p:nvSpPr>
        <p:spPr>
          <a:xfrm>
            <a:off x="618268" y="3599130"/>
            <a:ext cx="125547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Helvetica" pitchFamily="2" charset="0"/>
              </a:rPr>
              <a:t>Kale </a:t>
            </a:r>
          </a:p>
          <a:p>
            <a:pPr algn="ctr"/>
            <a:r>
              <a:rPr lang="en-US" sz="1600" dirty="0">
                <a:latin typeface="Helvetica" pitchFamily="2" charset="0"/>
              </a:rPr>
              <a:t>(CN Seeds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C7D257A-6562-9F12-883C-06F56417B2F0}"/>
              </a:ext>
            </a:extLst>
          </p:cNvPr>
          <p:cNvSpPr txBox="1"/>
          <p:nvPr/>
        </p:nvSpPr>
        <p:spPr>
          <a:xfrm>
            <a:off x="806622" y="5722096"/>
            <a:ext cx="8787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Helvetica" pitchFamily="2" charset="0"/>
              </a:rPr>
              <a:t>Radish </a:t>
            </a:r>
          </a:p>
        </p:txBody>
      </p:sp>
    </p:spTree>
    <p:extLst>
      <p:ext uri="{BB962C8B-B14F-4D97-AF65-F5344CB8AC3E}">
        <p14:creationId xmlns:p14="http://schemas.microsoft.com/office/powerpoint/2010/main" val="835119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37</TotalTime>
  <Words>61</Words>
  <Application>Microsoft Macintosh PowerPoint</Application>
  <PresentationFormat>A4 Paper (210x297 mm)</PresentationFormat>
  <Paragraphs>43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Ronald</dc:creator>
  <cp:lastModifiedBy>James Ronald</cp:lastModifiedBy>
  <cp:revision>8</cp:revision>
  <dcterms:created xsi:type="dcterms:W3CDTF">2024-04-21T12:54:39Z</dcterms:created>
  <dcterms:modified xsi:type="dcterms:W3CDTF">2024-05-08T08:00:14Z</dcterms:modified>
</cp:coreProperties>
</file>